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52419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ayout>
        <c:manualLayout>
          <c:xMode val="edge"/>
          <c:yMode val="edge"/>
          <c:x val="0.0199987500781201"/>
          <c:y val="0.0376401685593886"/>
          <c:w val="0.96000249984376"/>
          <c:h val="0.9423612599100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列 E</c:v>
                </c:pt>
              </c:strCache>
            </c:strRef>
          </c:tx>
          <c:spPr>
            <a:solidFill>
              <a:srgbClr val="9999ff"/>
            </a:solidFill>
            <a:ln w="0">
              <a:solidFill>
                <a:srgbClr val="000000"/>
              </a:solidFill>
            </a:ln>
          </c:spPr>
          <c:invertIfNegative val="0"/>
          <c:dLbls>
            <c:txPr>
              <a:bodyPr wrap="none"/>
              <a:lstStyle/>
              <a:p>
                <a:pPr>
                  <a:defRPr b="0" sz="1200" spc="-1" strike="noStrike">
                    <a:solidFill>
                      <a:srgbClr val="000000"/>
                    </a:solidFill>
                    <a:latin typeface="Sazanami Gothic"/>
                    <a:ea typeface="Sazanami Gothic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&gt;=1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9"/>
                <c:pt idx="0">
                  <c:v>249</c:v>
                </c:pt>
                <c:pt idx="1">
                  <c:v>268</c:v>
                </c:pt>
                <c:pt idx="2">
                  <c:v>77</c:v>
                </c:pt>
                <c:pt idx="3">
                  <c:v>111</c:v>
                </c:pt>
                <c:pt idx="4">
                  <c:v>116</c:v>
                </c:pt>
                <c:pt idx="5">
                  <c:v>74</c:v>
                </c:pt>
                <c:pt idx="6">
                  <c:v>20</c:v>
                </c:pt>
                <c:pt idx="7">
                  <c:v>27</c:v>
                </c:pt>
                <c:pt idx="8">
                  <c:v>245</c:v>
                </c:pt>
              </c:numCache>
            </c:numRef>
          </c:val>
        </c:ser>
        <c:gapWidth val="100"/>
        <c:overlap val="0"/>
        <c:axId val="56064563"/>
        <c:axId val="24896771"/>
      </c:barChart>
      <c:catAx>
        <c:axId val="560645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ln w="0">
            <a:solidFill>
              <a:srgbClr val="000000"/>
            </a:solidFill>
          </a:ln>
        </c:spPr>
        <c:txPr>
          <a:bodyPr/>
          <a:lstStyle/>
          <a:p>
            <a:pPr>
              <a:defRPr b="0" sz="1400" spc="-1" strike="noStrike">
                <a:solidFill>
                  <a:srgbClr val="000000"/>
                </a:solidFill>
                <a:latin typeface="Times New Roman"/>
                <a:ea typeface="Sazanami Gothic"/>
              </a:defRPr>
            </a:pPr>
          </a:p>
        </c:txPr>
        <c:crossAx val="24896771"/>
        <c:crossesAt val="0"/>
        <c:auto val="1"/>
        <c:lblAlgn val="ctr"/>
        <c:lblOffset val="100"/>
        <c:noMultiLvlLbl val="0"/>
      </c:catAx>
      <c:valAx>
        <c:axId val="24896771"/>
        <c:scaling>
          <c:orientation val="minMax"/>
        </c:scaling>
        <c:delete val="0"/>
        <c:axPos val="l"/>
        <c:majorGridlines>
          <c:spPr>
            <a:ln w="0">
              <a:solidFill>
                <a:srgbClr val="000000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 w="0">
            <a:solidFill>
              <a:srgbClr val="000000"/>
            </a:solidFill>
          </a:ln>
        </c:spPr>
        <c:txPr>
          <a:bodyPr/>
          <a:lstStyle/>
          <a:p>
            <a:pPr>
              <a:defRPr b="0" sz="1400" spc="-1" strike="noStrike">
                <a:solidFill>
                  <a:srgbClr val="000000"/>
                </a:solidFill>
                <a:latin typeface="Times New Roman"/>
                <a:ea typeface="Sazanami Gothic"/>
              </a:defRPr>
            </a:pPr>
          </a:p>
        </c:txPr>
        <c:crossAx val="56064563"/>
        <c:crosses val="min"/>
        <c:crossBetween val="between"/>
      </c:valAx>
      <c:spPr>
        <a:noFill/>
        <a:ln w="0">
          <a:noFill/>
        </a:ln>
      </c:spPr>
    </c:plotArea>
    <c:plotVisOnly val="0"/>
    <c:dispBlanksAs val="gap"/>
  </c:chart>
  <c:spPr>
    <a:solidFill>
      <a:srgbClr val="ffffff"/>
    </a:solidFill>
    <a:ln w="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BE430-2F2C-42F6-89C2-5DBC8BBD16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502128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3030120"/>
            <a:ext cx="502128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0F1C4-6D5C-452F-AB61-E5952CE4CE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303012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303012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0396C-DE6F-4AA6-B61B-1E999A9333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122220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122220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303012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303012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3030120"/>
            <a:ext cx="16167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3B4AA-ABEF-4E32-966B-4992F4BD1E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1222200"/>
            <a:ext cx="5021280" cy="3461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02525-2EED-4BE4-B061-8F72B4557D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502128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22C91-B6B8-47FD-8662-604591BC13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245016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1222200"/>
            <a:ext cx="245016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A724F-2882-4770-893B-598C95F374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EA41F-5097-413B-8171-D33D6C7876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209520"/>
            <a:ext cx="5021280" cy="4056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F7103-20F0-4A2E-AE66-37FBBBF118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1222200"/>
            <a:ext cx="245016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303012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DF5D1-B129-418F-B0A3-D41B406E1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245016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303012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36A7B-9BC5-4464-8C34-8B4AC0AB29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1222200"/>
            <a:ext cx="245016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3030120"/>
            <a:ext cx="5021280" cy="1650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FA446-4C5E-4391-A785-6732AD3BDE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209520"/>
            <a:ext cx="5021280" cy="8748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ctr">
            <a:noAutofit/>
          </a:bodyPr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1222200"/>
            <a:ext cx="5021280" cy="346104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rmAutofit/>
          </a:bodyPr>
          <a:p>
            <a:pPr marL="228600" indent="-22860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95360" indent="-19044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760320" indent="-15084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1065240" indent="-15228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370160" indent="-15264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370160" indent="-15264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370160" indent="-15264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4773600"/>
            <a:ext cx="1300320" cy="363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Autofit/>
          </a:bodyPr>
          <a:lstStyle>
            <a:lvl1pPr indent="0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4773600"/>
            <a:ext cx="1766880" cy="363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Autofit/>
          </a:bodyPr>
          <a:lstStyle>
            <a:lvl1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000320" y="4773600"/>
            <a:ext cx="1299960" cy="363600"/>
          </a:xfrm>
          <a:prstGeom prst="rect">
            <a:avLst/>
          </a:prstGeom>
          <a:noFill/>
          <a:ln w="0">
            <a:noFill/>
          </a:ln>
        </p:spPr>
        <p:txBody>
          <a:bodyPr lIns="60840" rIns="60840" tIns="30600" bIns="30600" anchor="t">
            <a:noAutofit/>
          </a:bodyPr>
          <a:lstStyle>
            <a:lvl1pPr indent="0" algn="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09480"/>
                <a:tab algn="l" pos="1219320"/>
                <a:tab algn="l" pos="1828800"/>
                <a:tab algn="l" pos="2438280"/>
                <a:tab algn="l" pos="3048120"/>
                <a:tab algn="l" pos="3657600"/>
                <a:tab algn="l" pos="4267080"/>
                <a:tab algn="l" pos="4876920"/>
                <a:tab algn="l" pos="5486400"/>
                <a:tab algn="l" pos="6095880"/>
                <a:tab algn="l" pos="6705720"/>
                <a:tab algn="l" pos="7315200"/>
                <a:tab algn="l" pos="7924680"/>
                <a:tab algn="l" pos="8534520"/>
                <a:tab algn="l" pos="9144000"/>
                <a:tab algn="l" pos="9753480"/>
                <a:tab algn="l" pos="10363320"/>
              </a:tabLst>
            </a:pPr>
            <a:fld id="{BBE9405B-7449-452C-81C5-F65E4F860F50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-57240"/>
            <a:ext cx="4408560" cy="39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720" rIns="81720" tIns="40680" bIns="4068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657360"/>
                <a:tab algn="l" pos="1312920"/>
                <a:tab algn="l" pos="1969920"/>
                <a:tab algn="l" pos="2627280"/>
                <a:tab algn="l" pos="3282840"/>
                <a:tab algn="l" pos="39402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  <a:tab algn="l" pos="8567640"/>
                <a:tab algn="l" pos="8975880"/>
                <a:tab algn="l" pos="9383760"/>
                <a:tab algn="l" pos="9791640"/>
                <a:tab algn="l" pos="10199520"/>
                <a:tab algn="l" pos="10607760"/>
              </a:tabLst>
            </a:pPr>
            <a:r>
              <a:rPr b="0" lang="en-GB" sz="2200" spc="-1" strike="noStrike">
                <a:solidFill>
                  <a:srgbClr val="000000"/>
                </a:solidFill>
                <a:latin typeface="Times New Roman"/>
              </a:rPr>
              <a:t>Additional file 1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45960" y="412920"/>
          <a:ext cx="522468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3" name=""/>
          <p:cNvSpPr/>
          <p:nvPr/>
        </p:nvSpPr>
        <p:spPr>
          <a:xfrm>
            <a:off x="1227240" y="4986360"/>
            <a:ext cx="3917880" cy="26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720" rIns="81720" tIns="40680" bIns="4068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657360"/>
                <a:tab algn="l" pos="1312920"/>
                <a:tab algn="l" pos="1969920"/>
                <a:tab algn="l" pos="2627280"/>
                <a:tab algn="l" pos="328284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  <a:tab algn="l" pos="8567640"/>
                <a:tab algn="l" pos="8975880"/>
                <a:tab algn="l" pos="9383760"/>
                <a:tab algn="l" pos="9791640"/>
                <a:tab algn="l" pos="10199520"/>
                <a:tab algn="l" pos="1060776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Times New Roman"/>
              </a:rPr>
              <a:t># of unique OMM sRNAs supporting substitution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0800000">
            <a:off x="-29880" y="1690560"/>
            <a:ext cx="347760" cy="166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720" rIns="81720" tIns="40680" bIns="40680" anchor="t" vert="eaVer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Times New Roman"/>
              </a:rPr>
              <a:t># of substitution site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0T19:24:30Z</dcterms:created>
  <dc:creator>Rebecca Stevenson</dc:creator>
  <dc:description/>
  <dc:language>en-US</dc:language>
  <cp:lastModifiedBy>Rebecca Stevenson</cp:lastModifiedBy>
  <dcterms:modified xsi:type="dcterms:W3CDTF">2009-04-01T18:24:36Z</dcterms:modified>
  <cp:revision>3</cp:revision>
  <dc:subject/>
  <dc:title>Slide 1</dc:title>
</cp:coreProperties>
</file>